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297" r:id="rId2"/>
    <p:sldId id="298" r:id="rId3"/>
    <p:sldId id="299" r:id="rId4"/>
    <p:sldId id="289" r:id="rId5"/>
  </p:sldIdLst>
  <p:sldSz cx="7315200" cy="10058400"/>
  <p:notesSz cx="6946900" cy="9271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30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ng,Benjamin J. (BIDMC - Radiation Oncology)" initials="LJ(-RO" lastIdx="1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00"/>
    <a:srgbClr val="CEED1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91" autoAdjust="0"/>
    <p:restoredTop sz="81222" autoAdjust="0"/>
  </p:normalViewPr>
  <p:slideViewPr>
    <p:cSldViewPr>
      <p:cViewPr varScale="1">
        <p:scale>
          <a:sx n="62" d="100"/>
          <a:sy n="62" d="100"/>
        </p:scale>
        <p:origin x="3192" y="216"/>
      </p:cViewPr>
      <p:guideLst>
        <p:guide orient="horz" pos="3168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18-01-05T19:13:08.665" idx="16">
    <p:pos x="4202" y="2935"/>
    <p:text>Can you add scale bar to these Ayesha?</p:text>
    <p:extLst>
      <p:ext uri="{C676402C-5697-4E1C-873F-D02D1690AC5C}">
        <p15:threadingInfo xmlns:p15="http://schemas.microsoft.com/office/powerpoint/2012/main" timeZoneBias="300"/>
      </p:ext>
    </p:extLst>
  </p:cm>
</p:cmLst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8C17F4CC-DA01-470E-A60E-628ABF32C63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09900" cy="465138"/>
          </a:xfrm>
          <a:prstGeom prst="rect">
            <a:avLst/>
          </a:prstGeom>
        </p:spPr>
        <p:txBody>
          <a:bodyPr vert="horz" lIns="91433" tIns="45716" rIns="91433" bIns="4571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ED44E65-10F9-4F99-9ADC-74C26DBCDAA1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935413" y="0"/>
            <a:ext cx="3009900" cy="465138"/>
          </a:xfrm>
          <a:prstGeom prst="rect">
            <a:avLst/>
          </a:prstGeom>
        </p:spPr>
        <p:txBody>
          <a:bodyPr vert="horz" lIns="91433" tIns="45716" rIns="91433" bIns="45716" rtlCol="0"/>
          <a:lstStyle>
            <a:lvl1pPr algn="r">
              <a:defRPr sz="1200"/>
            </a:lvl1pPr>
          </a:lstStyle>
          <a:p>
            <a:fld id="{03BD8DB6-BB80-423F-8679-6C7D6A942813}" type="datetimeFigureOut">
              <a:rPr lang="en-US" smtClean="0"/>
              <a:t>9/10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50E6DD-B5A5-4D51-B23B-CA719BA197D4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805864"/>
            <a:ext cx="3009900" cy="465137"/>
          </a:xfrm>
          <a:prstGeom prst="rect">
            <a:avLst/>
          </a:prstGeom>
        </p:spPr>
        <p:txBody>
          <a:bodyPr vert="horz" lIns="91433" tIns="45716" rIns="91433" bIns="4571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993DCD-10EF-4506-968E-ED552E55287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935413" y="8805864"/>
            <a:ext cx="3009900" cy="465137"/>
          </a:xfrm>
          <a:prstGeom prst="rect">
            <a:avLst/>
          </a:prstGeom>
        </p:spPr>
        <p:txBody>
          <a:bodyPr vert="horz" lIns="91433" tIns="45716" rIns="91433" bIns="45716" rtlCol="0" anchor="b"/>
          <a:lstStyle>
            <a:lvl1pPr algn="r">
              <a:defRPr sz="1200"/>
            </a:lvl1pPr>
          </a:lstStyle>
          <a:p>
            <a:fld id="{1B308800-D4FA-4C7B-B055-8E337EC3A6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2958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09900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35413" y="0"/>
            <a:ext cx="3009900" cy="4635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72AD13-9454-4DF0-A5AA-D1AE79A84DF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9800" y="695325"/>
            <a:ext cx="2527300" cy="3476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5" y="4403725"/>
            <a:ext cx="5556250" cy="41719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05863"/>
            <a:ext cx="3009900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35413" y="8805863"/>
            <a:ext cx="3009900" cy="4635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E7E128-85E5-4191-8A38-7B46E65916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3367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E7E128-85E5-4191-8A38-7B46E65916AE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6192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3124624"/>
            <a:ext cx="621792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97280" y="5699760"/>
            <a:ext cx="512064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2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947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43071" y="591397"/>
            <a:ext cx="1316990" cy="12586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2101" y="591397"/>
            <a:ext cx="3829050" cy="12586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4089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91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7850" y="6463454"/>
            <a:ext cx="621792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7850" y="4263180"/>
            <a:ext cx="621792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944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2100" y="3441277"/>
            <a:ext cx="2573020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87040" y="3441277"/>
            <a:ext cx="2573020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479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760" y="402802"/>
            <a:ext cx="658368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0" y="2251499"/>
            <a:ext cx="323215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760" y="3189817"/>
            <a:ext cx="323215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16020" y="2251499"/>
            <a:ext cx="323342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16020" y="3189817"/>
            <a:ext cx="323342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8278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448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178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761" y="400473"/>
            <a:ext cx="2406650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60040" y="400474"/>
            <a:ext cx="4089400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761" y="2104814"/>
            <a:ext cx="2406650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739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3830" y="7040880"/>
            <a:ext cx="438912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33830" y="898737"/>
            <a:ext cx="438912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33830" y="7872096"/>
            <a:ext cx="438912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082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5760" y="402802"/>
            <a:ext cx="658368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0" y="2346961"/>
            <a:ext cx="658368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5760" y="9322647"/>
            <a:ext cx="1706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C1004-10C5-4F9E-8A64-877AEFAC485E}" type="datetimeFigureOut">
              <a:rPr lang="en-US" smtClean="0"/>
              <a:t>9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9360" y="9322647"/>
            <a:ext cx="23164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42560" y="9322647"/>
            <a:ext cx="1706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F1F4E1-C10C-47BE-A5C0-DD2CB74DBE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641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openxmlformats.org/officeDocument/2006/relationships/image" Target="../media/image7.png"/><Relationship Id="rId4" Type="http://schemas.microsoft.com/office/2007/relationships/hdphoto" Target="../media/hdphoto1.wdp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png"/><Relationship Id="rId13" Type="http://schemas.microsoft.com/office/2007/relationships/hdphoto" Target="../media/hdphoto7.wdp"/><Relationship Id="rId3" Type="http://schemas.openxmlformats.org/officeDocument/2006/relationships/image" Target="../media/image17.png"/><Relationship Id="rId7" Type="http://schemas.openxmlformats.org/officeDocument/2006/relationships/image" Target="../media/image19.png"/><Relationship Id="rId12" Type="http://schemas.openxmlformats.org/officeDocument/2006/relationships/image" Target="../media/image22.png"/><Relationship Id="rId17" Type="http://schemas.openxmlformats.org/officeDocument/2006/relationships/comments" Target="../comments/comment1.xml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11" Type="http://schemas.microsoft.com/office/2007/relationships/hdphoto" Target="../media/hdphoto6.wdp"/><Relationship Id="rId5" Type="http://schemas.openxmlformats.org/officeDocument/2006/relationships/image" Target="../media/image18.png"/><Relationship Id="rId15" Type="http://schemas.microsoft.com/office/2007/relationships/hdphoto" Target="../media/hdphoto8.wdp"/><Relationship Id="rId10" Type="http://schemas.openxmlformats.org/officeDocument/2006/relationships/image" Target="../media/image21.png"/><Relationship Id="rId4" Type="http://schemas.microsoft.com/office/2007/relationships/hdphoto" Target="../media/hdphoto3.wdp"/><Relationship Id="rId9" Type="http://schemas.microsoft.com/office/2007/relationships/hdphoto" Target="../media/hdphoto5.wdp"/><Relationship Id="rId1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293" t="50000" r="33353"/>
          <a:stretch/>
        </p:blipFill>
        <p:spPr bwMode="auto">
          <a:xfrm>
            <a:off x="1071880" y="5182751"/>
            <a:ext cx="1445342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000" r="66624"/>
          <a:stretch/>
        </p:blipFill>
        <p:spPr bwMode="auto">
          <a:xfrm>
            <a:off x="2508348" y="5182751"/>
            <a:ext cx="1451429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647" t="50000"/>
          <a:stretch/>
        </p:blipFill>
        <p:spPr bwMode="auto">
          <a:xfrm>
            <a:off x="3959777" y="5182751"/>
            <a:ext cx="1450423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5" name="Straight Arrow Connector 4"/>
          <p:cNvCxnSpPr/>
          <p:nvPr/>
        </p:nvCxnSpPr>
        <p:spPr>
          <a:xfrm flipV="1">
            <a:off x="1594922" y="6249551"/>
            <a:ext cx="197089" cy="11430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/>
          <p:cNvCxnSpPr/>
          <p:nvPr/>
        </p:nvCxnSpPr>
        <p:spPr>
          <a:xfrm>
            <a:off x="5105400" y="6554351"/>
            <a:ext cx="2294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1071880" y="5210552"/>
            <a:ext cx="12141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Hsp90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90800" y="5241330"/>
            <a:ext cx="914400" cy="246221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72078" y="6450350"/>
            <a:ext cx="8329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EOC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1680" y="143938"/>
            <a:ext cx="20902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30000" contrast="-1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6158" y="3739908"/>
            <a:ext cx="1384042" cy="14428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1631" y="3739908"/>
            <a:ext cx="1370769" cy="14428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1880" y="3739907"/>
            <a:ext cx="1414298" cy="14265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071880" y="3740554"/>
            <a:ext cx="8331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90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/>
          <p:cNvCxnSpPr/>
          <p:nvPr/>
        </p:nvCxnSpPr>
        <p:spPr>
          <a:xfrm flipV="1">
            <a:off x="1397833" y="4017553"/>
            <a:ext cx="197089" cy="114300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5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6158" y="2264306"/>
            <a:ext cx="1384042" cy="14428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" name="Picture 6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6964" y="2264306"/>
            <a:ext cx="1362813" cy="14428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" name="Picture 7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2078" y="2264307"/>
            <a:ext cx="1445144" cy="14428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1066799" y="3430151"/>
            <a:ext cx="71222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EOC2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049733" y="4954151"/>
            <a:ext cx="7422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EOC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071880" y="2264306"/>
            <a:ext cx="523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1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602608" y="1987954"/>
            <a:ext cx="6070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005535" y="1981200"/>
            <a:ext cx="7126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99440" y="1978223"/>
            <a:ext cx="467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99440" y="3502223"/>
            <a:ext cx="467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99440" y="4953000"/>
            <a:ext cx="467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39581" y="6935636"/>
            <a:ext cx="527486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cs typeface="Times New Roman" panose="02020603050405020304" pitchFamily="18" charset="0"/>
              </a:rPr>
              <a:t>Supp. Fig. 1.Hsp90 alpha mitigates fibrillar amyloid beta neurotoxicity in EOC2 cells.  HT22 (hippocampal) cells were plated as in A and EOC2 cells were added on the top of the </a:t>
            </a:r>
            <a:r>
              <a:rPr lang="en-US" sz="1200" dirty="0" err="1">
                <a:cs typeface="Times New Roman" panose="02020603050405020304" pitchFamily="18" charset="0"/>
              </a:rPr>
              <a:t>transwell</a:t>
            </a:r>
            <a:r>
              <a:rPr lang="en-US" sz="1200" dirty="0">
                <a:cs typeface="Times New Roman" panose="02020603050405020304" pitchFamily="18" charset="0"/>
              </a:rPr>
              <a:t> culture plate and incubated with </a:t>
            </a:r>
            <a:r>
              <a:rPr lang="en-US" sz="1200" dirty="0" err="1">
                <a:cs typeface="Times New Roman" panose="02020603050405020304" pitchFamily="18" charset="0"/>
              </a:rPr>
              <a:t>fA</a:t>
            </a:r>
            <a:r>
              <a:rPr lang="en-US" sz="1200" dirty="0">
                <a:cs typeface="Times New Roman" panose="02020603050405020304" pitchFamily="18" charset="0"/>
              </a:rPr>
              <a:t>β + Hsp90α for 72 hours. HT22 cells were stained as in Fig. 1. Stained cells on coverslips were then examined with confocal microscope. Scale bar =5 µm,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03BE376-E785-C947-84B6-112B6CC36A05}"/>
              </a:ext>
            </a:extLst>
          </p:cNvPr>
          <p:cNvSpPr txBox="1"/>
          <p:nvPr/>
        </p:nvSpPr>
        <p:spPr>
          <a:xfrm>
            <a:off x="914400" y="914400"/>
            <a:ext cx="589443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DATA : </a:t>
            </a:r>
            <a:r>
              <a:rPr lang="en-US" b="1" dirty="0"/>
              <a:t>Extracellular Hsp90α Detoxifies β-</a:t>
            </a:r>
          </a:p>
          <a:p>
            <a:r>
              <a:rPr lang="en-US" b="1" dirty="0"/>
              <a:t>Amyloid Fibrils Through an Nrf2 and Autophagy Dependent </a:t>
            </a:r>
          </a:p>
          <a:p>
            <a:r>
              <a:rPr lang="en-US" b="1" dirty="0"/>
              <a:t>Pathway, </a:t>
            </a:r>
            <a:r>
              <a:rPr lang="en-US" dirty="0"/>
              <a:t>Murshid A. et al., BIDMC, Harvard Medical School</a:t>
            </a:r>
          </a:p>
        </p:txBody>
      </p:sp>
    </p:spTree>
    <p:extLst>
      <p:ext uri="{BB962C8B-B14F-4D97-AF65-F5344CB8AC3E}">
        <p14:creationId xmlns:p14="http://schemas.microsoft.com/office/powerpoint/2010/main" val="35718957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6159"/>
          <a:stretch/>
        </p:blipFill>
        <p:spPr bwMode="auto">
          <a:xfrm>
            <a:off x="827381" y="3864860"/>
            <a:ext cx="4974472" cy="144046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3" name="Straight Arrow Connector 2"/>
          <p:cNvCxnSpPr/>
          <p:nvPr/>
        </p:nvCxnSpPr>
        <p:spPr>
          <a:xfrm flipV="1">
            <a:off x="1770072" y="4654661"/>
            <a:ext cx="134928" cy="6435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/>
          <p:cNvCxnSpPr/>
          <p:nvPr/>
        </p:nvCxnSpPr>
        <p:spPr>
          <a:xfrm flipV="1">
            <a:off x="1832519" y="4390836"/>
            <a:ext cx="224881" cy="1077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11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797" t="77115" r="1314" b="13615"/>
          <a:stretch/>
        </p:blipFill>
        <p:spPr bwMode="auto">
          <a:xfrm>
            <a:off x="4267200" y="3895368"/>
            <a:ext cx="912719" cy="871815"/>
          </a:xfrm>
          <a:prstGeom prst="rect">
            <a:avLst/>
          </a:prstGeom>
          <a:noFill/>
          <a:ln w="19050">
            <a:solidFill>
              <a:schemeClr val="bg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" name="Straight Connector 5"/>
          <p:cNvCxnSpPr/>
          <p:nvPr/>
        </p:nvCxnSpPr>
        <p:spPr>
          <a:xfrm>
            <a:off x="5486400" y="5111861"/>
            <a:ext cx="2294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793870" y="4987262"/>
            <a:ext cx="3491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5762" y="9372600"/>
            <a:ext cx="18616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 2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91759" y="2216261"/>
            <a:ext cx="1510094" cy="14668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2216261"/>
            <a:ext cx="1481177" cy="14668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4600" y="2209800"/>
            <a:ext cx="1534382" cy="14542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838200" y="3402451"/>
            <a:ext cx="6632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hr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5486400" y="3581400"/>
            <a:ext cx="2294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843280" y="5413689"/>
            <a:ext cx="527486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2. Addition of Hsp90 alpha increases the uptak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ta in EOC2 cells. The EOC2 cells were treat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4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fAβ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4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Hsp90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2 h at which time cells were fixed, stained with DAPI and observed by fluorescence microscopy, scale bar =5µm, n=100  .  </a:t>
            </a:r>
            <a:endParaRPr 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70533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7457"/>
          <a:stretch/>
        </p:blipFill>
        <p:spPr bwMode="auto">
          <a:xfrm>
            <a:off x="1254789" y="1378139"/>
            <a:ext cx="4568997" cy="13181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685800" y="1219200"/>
            <a:ext cx="467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4" name="Straight Connector 3"/>
          <p:cNvCxnSpPr/>
          <p:nvPr/>
        </p:nvCxnSpPr>
        <p:spPr>
          <a:xfrm>
            <a:off x="5485559" y="2696289"/>
            <a:ext cx="2294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1174870" y="4648200"/>
            <a:ext cx="3491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1962" y="9296400"/>
            <a:ext cx="20902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 3</a:t>
            </a:r>
          </a:p>
        </p:txBody>
      </p:sp>
      <p:pic>
        <p:nvPicPr>
          <p:cNvPr id="8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9400" y="2875279"/>
            <a:ext cx="1371600" cy="12786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5400" y="2908301"/>
            <a:ext cx="1317565" cy="12456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7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5800" y="2875279"/>
            <a:ext cx="1327986" cy="12786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680720" y="2723635"/>
            <a:ext cx="467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19199" y="3853190"/>
            <a:ext cx="13937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+Hsp90</a:t>
            </a:r>
            <a:r>
              <a:rPr lang="el-GR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4hr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192688" y="2438400"/>
            <a:ext cx="22313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100" dirty="0"/>
          </a:p>
        </p:txBody>
      </p:sp>
      <p:sp>
        <p:nvSpPr>
          <p:cNvPr id="14" name="TextBox 13"/>
          <p:cNvSpPr txBox="1"/>
          <p:nvPr/>
        </p:nvSpPr>
        <p:spPr>
          <a:xfrm>
            <a:off x="2831593" y="3892339"/>
            <a:ext cx="685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419600" y="3886200"/>
            <a:ext cx="6858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695960" y="4362239"/>
            <a:ext cx="5274867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3. Fate of internalized FITC-labeled fAbeta1-42 in EOC2 cells. EOC2 cells were treated with treat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4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4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Hsp90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for 24 h at which time cells were fixed, stained with DAPI and observed by fluorescence microscopy, scale bar =5 µm  , n= 100 .  </a:t>
            </a:r>
            <a:endParaRPr 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Straight Connector 16"/>
          <p:cNvCxnSpPr/>
          <p:nvPr/>
        </p:nvCxnSpPr>
        <p:spPr>
          <a:xfrm>
            <a:off x="5485558" y="4025123"/>
            <a:ext cx="2294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486400" y="2590800"/>
            <a:ext cx="2294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884976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141994" y="9372600"/>
            <a:ext cx="20902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 4</a:t>
            </a:r>
          </a:p>
        </p:txBody>
      </p:sp>
      <p:pic>
        <p:nvPicPr>
          <p:cNvPr id="30" name="Picture 29"/>
          <p:cNvPicPr>
            <a:picLocks noChangeAspect="1" noChangeArrowheads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100000"/>
                    </a14:imgEffect>
                    <a14:imgEffect>
                      <a14:brightnessContrast bright="24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10680" y="1861897"/>
            <a:ext cx="1516072" cy="1457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30"/>
          <p:cNvPicPr>
            <a:picLocks noChangeAspect="1" noChangeArrowheads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 contrast="-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8803" y="1850491"/>
            <a:ext cx="1549082" cy="1457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31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7691" y="1850491"/>
            <a:ext cx="1549082" cy="1457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32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7252" y="1873472"/>
            <a:ext cx="1549083" cy="145796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33"/>
          <p:cNvPicPr>
            <a:picLocks noChangeAspect="1" noChangeArrowheads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7000" contras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5475" y="3352800"/>
            <a:ext cx="1516072" cy="15465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34"/>
          <p:cNvPicPr>
            <a:picLocks noChangeAspect="1" noChangeArrowheads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5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8803" y="3365339"/>
            <a:ext cx="1549082" cy="15465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" name="Picture 35"/>
          <p:cNvPicPr>
            <a:picLocks noChangeAspect="1" noChangeArrowheads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61000"/>
                    </a14:imgEffect>
                    <a14:imgEffect>
                      <a14:brightnessContrast bright="13000" contrast="3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27888" y="3365339"/>
            <a:ext cx="1549718" cy="15465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7" name="Picture 36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371" y="3365339"/>
            <a:ext cx="1569402" cy="15465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Rectangle 37"/>
          <p:cNvSpPr/>
          <p:nvPr/>
        </p:nvSpPr>
        <p:spPr>
          <a:xfrm>
            <a:off x="883124" y="1581427"/>
            <a:ext cx="87821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TC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1979" y="2439977"/>
            <a:ext cx="4657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Scr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241486" y="1562522"/>
            <a:ext cx="7745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745690" y="1588881"/>
            <a:ext cx="6756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2677132" y="1571000"/>
            <a:ext cx="89377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-25400" y="3925876"/>
            <a:ext cx="8229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iNrf2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72988" y="5105400"/>
            <a:ext cx="67116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4. Nrf2 is not required fo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 uptake in microglia. </a:t>
            </a:r>
            <a:r>
              <a:rPr lang="mr-I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V-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incubated with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r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N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f2 siRN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72 h. Cells were then incubated with FITC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4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2 h. Cells were then fixed, permeabilized and stained with anti Nrf2 antibody (red) and DAPI (blue), scale bar= ,</a:t>
            </a:r>
          </a:p>
        </p:txBody>
      </p:sp>
    </p:spTree>
    <p:extLst>
      <p:ext uri="{BB962C8B-B14F-4D97-AF65-F5344CB8AC3E}">
        <p14:creationId xmlns:p14="http://schemas.microsoft.com/office/powerpoint/2010/main" val="32695949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7923</TotalTime>
  <Words>349</Words>
  <Application>Microsoft Macintosh PowerPoint</Application>
  <PresentationFormat>Custom</PresentationFormat>
  <Paragraphs>39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rshid,Ayesha (BIDMC - Radiation Oncology)</dc:creator>
  <cp:lastModifiedBy>Laura Greene</cp:lastModifiedBy>
  <cp:revision>209</cp:revision>
  <cp:lastPrinted>2018-02-05T15:09:00Z</cp:lastPrinted>
  <dcterms:created xsi:type="dcterms:W3CDTF">2016-11-16T20:00:27Z</dcterms:created>
  <dcterms:modified xsi:type="dcterms:W3CDTF">2020-09-10T17:25:11Z</dcterms:modified>
</cp:coreProperties>
</file>